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92" d="100"/>
          <a:sy n="92" d="100"/>
        </p:scale>
        <p:origin x="1176" y="7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3E48CC3-A9D0-BB83-5548-FC6A0EA33F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89EB9D10-D76E-D60A-F985-B9262BFE2E1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60FB54D-8EFE-73D1-9FBC-CB72BA5765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84FA9-8783-4E3F-914C-95EDF9BB08B8}" type="datetimeFigureOut">
              <a:rPr lang="zh-CN" altLang="en-US" smtClean="0"/>
              <a:t>2024/11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5AD07D5-8F07-ABB9-6A0B-E396543A67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96D8204-E39D-3DAA-4375-8BD2F56B4F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2050E-F228-4E7C-A46A-490ABF3F96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53382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BD559F0-68FB-5935-879C-B3F6CCF888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2E624ED-A375-F9A2-A872-935709E14E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1DAC593-E8BA-D9D0-7823-EAF1272504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84FA9-8783-4E3F-914C-95EDF9BB08B8}" type="datetimeFigureOut">
              <a:rPr lang="zh-CN" altLang="en-US" smtClean="0"/>
              <a:t>2024/11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8ED3563-D21C-41DB-A106-0F517C437F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383B9F4-AA57-A0D0-EF86-61D648187D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2050E-F228-4E7C-A46A-490ABF3F96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76955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0FB4D050-BF81-88A6-CCDE-EDB436D3560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BC9356E-F304-932B-389D-1D77719453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E059F77-C8A3-2171-E4D7-9E3EA9C8C7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84FA9-8783-4E3F-914C-95EDF9BB08B8}" type="datetimeFigureOut">
              <a:rPr lang="zh-CN" altLang="en-US" smtClean="0"/>
              <a:t>2024/11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54A63EF-C509-9CFE-0DEA-AA27D11143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432F15F-0BE0-4D48-83C6-39295D6DEB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2050E-F228-4E7C-A46A-490ABF3F96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96440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98696AD-F072-5D37-D2D6-1EA6CFDBFE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C023A78-1ABA-33F8-7414-5B1A25C75E6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87A2884-5728-C2C1-FD6A-32B564E60B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84FA9-8783-4E3F-914C-95EDF9BB08B8}" type="datetimeFigureOut">
              <a:rPr lang="zh-CN" altLang="en-US" smtClean="0"/>
              <a:t>2024/11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491389D-6AB6-346E-5218-F234D35A89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A4B6283-77E4-D0DF-F81B-DF00508ACE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2050E-F228-4E7C-A46A-490ABF3F96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44718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4C19327-54DD-2E1F-6B26-65B2D8F78C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8A7A289-72FE-5AEC-6EBD-E17AB1F67E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031EBA9-00DD-2EE0-0FF6-432437D83C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84FA9-8783-4E3F-914C-95EDF9BB08B8}" type="datetimeFigureOut">
              <a:rPr lang="zh-CN" altLang="en-US" smtClean="0"/>
              <a:t>2024/11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09C4482-CE78-5072-D797-75DFD9A96C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12CAD23-2983-A99E-F235-9B1668F21C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2050E-F228-4E7C-A46A-490ABF3F96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33270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24286E4-295E-E63A-D3E2-A92E088EC3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DCE51F5-D54B-E62F-E0DB-C8889EF76A3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E1164F5-3F25-996E-41F3-863B51C50E8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FADE573-3BFA-E509-E10F-CC50E104F3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84FA9-8783-4E3F-914C-95EDF9BB08B8}" type="datetimeFigureOut">
              <a:rPr lang="zh-CN" altLang="en-US" smtClean="0"/>
              <a:t>2024/11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968D834-F8EB-B86D-06B3-2AEE43A8AA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A286006-BFA9-97A2-60B7-3CBDEC30AF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2050E-F228-4E7C-A46A-490ABF3F96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37192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9357FC0-EBD5-1D80-E2F1-99ACB1441E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1CF1176-912D-165C-1B5E-4CBEC54710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88B8E78-A77A-2170-9EA9-BD8CA048F5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F38C8CF8-24E8-B06D-28AA-01296068639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1C97CC6-E2F3-C18E-1457-D7781FA4476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298E1EEC-0284-BFCE-0A92-67BB631EE0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84FA9-8783-4E3F-914C-95EDF9BB08B8}" type="datetimeFigureOut">
              <a:rPr lang="zh-CN" altLang="en-US" smtClean="0"/>
              <a:t>2024/11/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F492790F-0EF0-C92D-4A50-7479981B5A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BABBF659-B55B-411A-B216-49D208DB76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2050E-F228-4E7C-A46A-490ABF3F96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2001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4C93134-BCBA-D566-CBE4-8CE92856B0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A24282F-BD8D-5462-B0C1-64653FA3D1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84FA9-8783-4E3F-914C-95EDF9BB08B8}" type="datetimeFigureOut">
              <a:rPr lang="zh-CN" altLang="en-US" smtClean="0"/>
              <a:t>2024/11/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86576036-F198-8D98-67FF-E6A3054E5C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72EED20A-B3A5-83CD-1EDB-C285411D63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2050E-F228-4E7C-A46A-490ABF3F96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60362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51B50335-DEF3-324C-93E9-217299EB3C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84FA9-8783-4E3F-914C-95EDF9BB08B8}" type="datetimeFigureOut">
              <a:rPr lang="zh-CN" altLang="en-US" smtClean="0"/>
              <a:t>2024/11/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F5F16271-7779-EFFA-34CB-25E9F07CF3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EAEDA2C5-E11B-C3E8-0AA4-975972A255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2050E-F228-4E7C-A46A-490ABF3F96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66769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E81B515-F27A-EFAB-9273-CB23AF975B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FFAE83E-A789-0CBF-B65B-C7D9830B1F4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5D4A5B8-FB30-D604-7F31-8A857128E2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62DF41C-4A70-F04E-7531-0052323FE0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84FA9-8783-4E3F-914C-95EDF9BB08B8}" type="datetimeFigureOut">
              <a:rPr lang="zh-CN" altLang="en-US" smtClean="0"/>
              <a:t>2024/11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AA9F419-3846-7657-736E-FF9FECFC12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B0FAD1B-F357-0074-8E4C-1CAD36C3CA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2050E-F228-4E7C-A46A-490ABF3F96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67551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AF36C9C-5693-3FCA-0ABE-65179001B8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54768DA5-60EE-8661-FB42-D538DED322E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C4BDFFB-193A-842C-B0FB-7A48682BA4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4DD8A53-9089-9665-2070-412CA41E6D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84FA9-8783-4E3F-914C-95EDF9BB08B8}" type="datetimeFigureOut">
              <a:rPr lang="zh-CN" altLang="en-US" smtClean="0"/>
              <a:t>2024/11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475E09D-0B69-558B-F51B-90CA0B8624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50C677B-A459-512F-1769-46F3E8C871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2050E-F228-4E7C-A46A-490ABF3F96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04247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1D41475-0CA1-A12A-9130-6F14B287BC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4943B8E-628F-5AB0-E4DD-E61617AAAD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A5F227D-243B-9B67-08B6-0753F9B2EAC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C784FA9-8783-4E3F-914C-95EDF9BB08B8}" type="datetimeFigureOut">
              <a:rPr lang="zh-CN" altLang="en-US" smtClean="0"/>
              <a:t>2024/11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C1AB3BA-56B4-6CFE-E111-EF3BB33CB4F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C061BAB-76EC-9029-BC50-48D2537CB81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352050E-F228-4E7C-A46A-490ABF3F96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380241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40BB78D8-3738-DDFE-BECD-764DE53E316F}"/>
              </a:ext>
            </a:extLst>
          </p:cNvPr>
          <p:cNvSpPr txBox="1"/>
          <p:nvPr/>
        </p:nvSpPr>
        <p:spPr>
          <a:xfrm>
            <a:off x="2226251" y="5350438"/>
            <a:ext cx="874654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endParaRPr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4D55E4F5-2592-1769-D907-8DC1B91EC8A3}"/>
              </a:ext>
            </a:extLst>
          </p:cNvPr>
          <p:cNvSpPr txBox="1"/>
          <p:nvPr/>
        </p:nvSpPr>
        <p:spPr>
          <a:xfrm>
            <a:off x="2020981" y="4088618"/>
            <a:ext cx="7664062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b="1" dirty="0">
                <a:solidFill>
                  <a:srgbClr val="000000"/>
                </a:solidFill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1</a:t>
            </a:r>
            <a:r>
              <a:rPr lang="en-US" altLang="zh-CN" dirty="0">
                <a:solidFill>
                  <a:srgbClr val="000000"/>
                </a:solidFill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Correlation coefficients among 3 traits in the RIL population of two environments. a and </a:t>
            </a:r>
            <a:r>
              <a:rPr lang="en-US" altLang="zh-CN">
                <a:solidFill>
                  <a:srgbClr val="000000"/>
                </a:solidFill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 indicate </a:t>
            </a:r>
            <a:r>
              <a:rPr lang="en-US" altLang="zh-CN" dirty="0">
                <a:solidFill>
                  <a:srgbClr val="000000"/>
                </a:solidFill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2023 first season and 2023 second season, respectively. The upper panel contains significance analysis, and the lower panel contains correlation coefficients. ** represent significance levels at 0.01, respectively.</a:t>
            </a:r>
            <a:endParaRPr lang="zh-CN" altLang="en-US" dirty="0">
              <a:solidFill>
                <a:srgbClr val="000000"/>
              </a:solidFill>
              <a:latin typeface="Palatino Linotype" panose="0204050205050503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grpSp>
        <p:nvGrpSpPr>
          <p:cNvPr id="7" name="组合 6">
            <a:extLst>
              <a:ext uri="{FF2B5EF4-FFF2-40B4-BE49-F238E27FC236}">
                <a16:creationId xmlns:a16="http://schemas.microsoft.com/office/drawing/2014/main" id="{AF04BCFC-FC13-5905-D07E-88E0CBB10168}"/>
              </a:ext>
            </a:extLst>
          </p:cNvPr>
          <p:cNvGrpSpPr/>
          <p:nvPr/>
        </p:nvGrpSpPr>
        <p:grpSpPr>
          <a:xfrm>
            <a:off x="1839191" y="394855"/>
            <a:ext cx="7548631" cy="3523229"/>
            <a:chOff x="2800181" y="749313"/>
            <a:chExt cx="6591638" cy="3087733"/>
          </a:xfrm>
        </p:grpSpPr>
        <p:grpSp>
          <p:nvGrpSpPr>
            <p:cNvPr id="8" name="组合 7">
              <a:extLst>
                <a:ext uri="{FF2B5EF4-FFF2-40B4-BE49-F238E27FC236}">
                  <a16:creationId xmlns:a16="http://schemas.microsoft.com/office/drawing/2014/main" id="{BF5DE97E-EF82-B814-998B-54E04DF0554E}"/>
                </a:ext>
              </a:extLst>
            </p:cNvPr>
            <p:cNvGrpSpPr/>
            <p:nvPr/>
          </p:nvGrpSpPr>
          <p:grpSpPr>
            <a:xfrm>
              <a:off x="2800181" y="749313"/>
              <a:ext cx="6591638" cy="3087733"/>
              <a:chOff x="2395096" y="994410"/>
              <a:chExt cx="6591638" cy="3087733"/>
            </a:xfrm>
          </p:grpSpPr>
          <p:pic>
            <p:nvPicPr>
              <p:cNvPr id="13" name="图片 12" descr="图表, 气泡图&#10;&#10;描述已自动生成">
                <a:extLst>
                  <a:ext uri="{FF2B5EF4-FFF2-40B4-BE49-F238E27FC236}">
                    <a16:creationId xmlns:a16="http://schemas.microsoft.com/office/drawing/2014/main" id="{874A2205-A887-339F-1471-598E0418E8D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690915" y="994410"/>
                <a:ext cx="3295819" cy="3087733"/>
              </a:xfrm>
              <a:prstGeom prst="rect">
                <a:avLst/>
              </a:prstGeom>
            </p:spPr>
          </p:pic>
          <p:pic>
            <p:nvPicPr>
              <p:cNvPr id="14" name="图片 13" descr="图表&#10;&#10;描述已自动生成">
                <a:extLst>
                  <a:ext uri="{FF2B5EF4-FFF2-40B4-BE49-F238E27FC236}">
                    <a16:creationId xmlns:a16="http://schemas.microsoft.com/office/drawing/2014/main" id="{0E5E061D-7F35-FE28-DB84-EEB817306B0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395096" y="994410"/>
                <a:ext cx="3295819" cy="3087733"/>
              </a:xfrm>
              <a:prstGeom prst="rect">
                <a:avLst/>
              </a:prstGeom>
            </p:spPr>
          </p:pic>
          <p:sp>
            <p:nvSpPr>
              <p:cNvPr id="15" name="文本框 7">
                <a:extLst>
                  <a:ext uri="{FF2B5EF4-FFF2-40B4-BE49-F238E27FC236}">
                    <a16:creationId xmlns:a16="http://schemas.microsoft.com/office/drawing/2014/main" id="{43C90AB4-69C8-5F81-5D78-B7456430C9FC}"/>
                  </a:ext>
                </a:extLst>
              </p:cNvPr>
              <p:cNvSpPr txBox="1"/>
              <p:nvPr/>
            </p:nvSpPr>
            <p:spPr>
              <a:xfrm>
                <a:off x="2405160" y="1108726"/>
                <a:ext cx="356895" cy="3077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文本框 7">
                <a:extLst>
                  <a:ext uri="{FF2B5EF4-FFF2-40B4-BE49-F238E27FC236}">
                    <a16:creationId xmlns:a16="http://schemas.microsoft.com/office/drawing/2014/main" id="{EA4415D8-967C-901C-2F3A-9A0ECBC8E825}"/>
                  </a:ext>
                </a:extLst>
              </p:cNvPr>
              <p:cNvSpPr txBox="1"/>
              <p:nvPr/>
            </p:nvSpPr>
            <p:spPr>
              <a:xfrm>
                <a:off x="5644416" y="1108726"/>
                <a:ext cx="356895" cy="3077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235674E5-C450-769B-F6B5-C07B478C0675}"/>
                </a:ext>
              </a:extLst>
            </p:cNvPr>
            <p:cNvSpPr txBox="1"/>
            <p:nvPr/>
          </p:nvSpPr>
          <p:spPr>
            <a:xfrm>
              <a:off x="5183686" y="1210799"/>
              <a:ext cx="478410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b="1" dirty="0"/>
                <a:t>**</a:t>
              </a:r>
              <a:endParaRPr lang="zh-CN" altLang="en-US" b="1" dirty="0"/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E6093D12-82FC-0E50-F998-31FBF859D709}"/>
                </a:ext>
              </a:extLst>
            </p:cNvPr>
            <p:cNvSpPr txBox="1"/>
            <p:nvPr/>
          </p:nvSpPr>
          <p:spPr>
            <a:xfrm>
              <a:off x="5183686" y="2073768"/>
              <a:ext cx="478410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b="1" dirty="0"/>
                <a:t>**</a:t>
              </a:r>
              <a:endParaRPr lang="zh-CN" altLang="en-US" b="1" dirty="0"/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4CA7C7A5-B44E-5A82-3E80-1B4F4ED8F765}"/>
                </a:ext>
              </a:extLst>
            </p:cNvPr>
            <p:cNvSpPr txBox="1"/>
            <p:nvPr/>
          </p:nvSpPr>
          <p:spPr>
            <a:xfrm>
              <a:off x="8488932" y="1210799"/>
              <a:ext cx="478410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b="1" dirty="0"/>
                <a:t>**</a:t>
              </a:r>
              <a:endParaRPr lang="zh-CN" altLang="en-US" b="1" dirty="0"/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26784C74-8815-A13B-7460-54671D5A9920}"/>
                </a:ext>
              </a:extLst>
            </p:cNvPr>
            <p:cNvSpPr txBox="1"/>
            <p:nvPr/>
          </p:nvSpPr>
          <p:spPr>
            <a:xfrm>
              <a:off x="8488932" y="2073768"/>
              <a:ext cx="478410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b="1" dirty="0"/>
                <a:t>**</a:t>
              </a:r>
              <a:endParaRPr lang="zh-CN" altLang="en-US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1565602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61</Words>
  <Application>Microsoft Office PowerPoint</Application>
  <PresentationFormat>宽屏</PresentationFormat>
  <Paragraphs>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Palatino Linotype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office</dc:creator>
  <cp:lastModifiedBy>office</cp:lastModifiedBy>
  <cp:revision>4</cp:revision>
  <dcterms:created xsi:type="dcterms:W3CDTF">2024-11-07T15:40:44Z</dcterms:created>
  <dcterms:modified xsi:type="dcterms:W3CDTF">2024-11-07T15:45:23Z</dcterms:modified>
</cp:coreProperties>
</file>